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1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59360" cy="3719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1680"/>
            <a:ext cx="5435640" cy="446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B64F3A-64F2-44B5-AD74-80922E18584D}" type="slidenum">
              <a:rPr b="0" lang="ko-KR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59360" cy="3719520"/>
          </a:xfrm>
          <a:prstGeom prst="rect">
            <a:avLst/>
          </a:prstGeom>
          <a:ln w="0">
            <a:noFill/>
          </a:ln>
        </p:spPr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678960" y="4711680"/>
            <a:ext cx="5435640" cy="44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2" name="슬라이드 번호 개체 틀 3"/>
          <p:cNvSpPr/>
          <p:nvPr/>
        </p:nvSpPr>
        <p:spPr>
          <a:xfrm>
            <a:off x="3848040" y="9421920"/>
            <a:ext cx="294480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9B0C0D-CEBD-492C-ACB7-A0F9F5F10F2D}" type="slidenum">
              <a:rPr b="0" lang="ko-KR" sz="1200" spc="-1" strike="noStrike">
                <a:solidFill>
                  <a:srgbClr val="000000"/>
                </a:solidFill>
                <a:latin typeface="굴림"/>
                <a:ea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84585A-8463-41BA-ABF9-03440005B5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CBFA5-3258-4FF2-9A96-9AE95C82EC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9AA95-9E5A-4909-A903-7D361EAEE9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8FD9E-335C-4C9C-849C-5DF3F9362F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EF40C-2ECE-4068-BDE6-7DA289A0F1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34F1B-A334-4F0E-BF1D-0271BCE8A7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72CB6-7813-43D9-967B-D57632D7EC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93784A-0044-4BBF-AC57-DC6E8389B2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F1F2D-114A-4229-802A-29069E75B3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60776-BAC0-4441-B85C-C02A3A7B31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1FAFC-61BF-416E-B6FF-19F6CAAED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28453-B368-49FA-8BEA-C29FB5C6F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D4EBE6-BCCD-476D-B5DE-3293EFB7A75F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직사각형 82"/>
          <p:cNvSpPr/>
          <p:nvPr/>
        </p:nvSpPr>
        <p:spPr>
          <a:xfrm>
            <a:off x="6108840" y="5130720"/>
            <a:ext cx="2936880" cy="100332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직사각형 81"/>
          <p:cNvSpPr/>
          <p:nvPr/>
        </p:nvSpPr>
        <p:spPr>
          <a:xfrm>
            <a:off x="6108840" y="4124160"/>
            <a:ext cx="2936880" cy="1005120"/>
          </a:xfrm>
          <a:prstGeom prst="rect">
            <a:avLst/>
          </a:prstGeom>
          <a:solidFill>
            <a:srgbClr val="f2f2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직사각형 74"/>
          <p:cNvSpPr/>
          <p:nvPr/>
        </p:nvSpPr>
        <p:spPr>
          <a:xfrm>
            <a:off x="6108840" y="3121200"/>
            <a:ext cx="2936880" cy="10047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1" name="직사각형 73"/>
          <p:cNvSpPr/>
          <p:nvPr/>
        </p:nvSpPr>
        <p:spPr>
          <a:xfrm>
            <a:off x="6108840" y="1104840"/>
            <a:ext cx="2936880" cy="10051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2" name="직사각형 71"/>
          <p:cNvSpPr/>
          <p:nvPr/>
        </p:nvSpPr>
        <p:spPr>
          <a:xfrm>
            <a:off x="3046320" y="4124160"/>
            <a:ext cx="3035520" cy="100512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3" name="직사각형 70"/>
          <p:cNvSpPr/>
          <p:nvPr/>
        </p:nvSpPr>
        <p:spPr>
          <a:xfrm>
            <a:off x="3046320" y="3121200"/>
            <a:ext cx="3035520" cy="10047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직사각형 69"/>
          <p:cNvSpPr/>
          <p:nvPr/>
        </p:nvSpPr>
        <p:spPr>
          <a:xfrm>
            <a:off x="98280" y="3121200"/>
            <a:ext cx="2922840" cy="10047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직사각형 28"/>
          <p:cNvSpPr/>
          <p:nvPr/>
        </p:nvSpPr>
        <p:spPr>
          <a:xfrm>
            <a:off x="98280" y="2114640"/>
            <a:ext cx="2922840" cy="100476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6200640" y="771480"/>
          <a:ext cx="2822760" cy="5365800"/>
        </p:xfrm>
        <a:graphic>
          <a:graphicData uri="http://schemas.openxmlformats.org/drawingml/2006/table">
            <a:tbl>
              <a:tblPr/>
              <a:tblGrid>
                <a:gridCol w="590760"/>
                <a:gridCol w="666720"/>
                <a:gridCol w="309600"/>
                <a:gridCol w="291960"/>
                <a:gridCol w="292320"/>
                <a:gridCol w="671400"/>
              </a:tblGrid>
              <a:tr h="351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288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/mouse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 baseline="-25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.8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2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7" name=""/>
          <p:cNvGraphicFramePr/>
          <p:nvPr/>
        </p:nvGraphicFramePr>
        <p:xfrm>
          <a:off x="3138480" y="771480"/>
          <a:ext cx="2847960" cy="5365800"/>
        </p:xfrm>
        <a:graphic>
          <a:graphicData uri="http://schemas.openxmlformats.org/drawingml/2006/table">
            <a:tbl>
              <a:tblPr/>
              <a:tblGrid>
                <a:gridCol w="563400"/>
                <a:gridCol w="655920"/>
                <a:gridCol w="333360"/>
                <a:gridCol w="296640"/>
                <a:gridCol w="295560"/>
                <a:gridCol w="703080"/>
              </a:tblGrid>
              <a:tr h="351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7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/mouse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.D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.D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.1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8" name=""/>
          <p:cNvGraphicFramePr/>
          <p:nvPr/>
        </p:nvGraphicFramePr>
        <p:xfrm>
          <a:off x="117360" y="771480"/>
          <a:ext cx="2808360" cy="5365800"/>
        </p:xfrm>
        <a:graphic>
          <a:graphicData uri="http://schemas.openxmlformats.org/drawingml/2006/table">
            <a:tbl>
              <a:tblPr/>
              <a:tblGrid>
                <a:gridCol w="576360"/>
                <a:gridCol w="669960"/>
                <a:gridCol w="290520"/>
                <a:gridCol w="290520"/>
                <a:gridCol w="290520"/>
                <a:gridCol w="690480"/>
              </a:tblGrid>
              <a:tr h="3510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irus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noculum</a:t>
                      </a: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I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7400"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PFU/mous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liv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ea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ota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D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50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U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A</a:t>
                      </a:r>
                      <a:r>
                        <a:rPr b="1" lang="en-US" sz="1100" spc="-1" strike="noStrike" baseline="-14000">
                          <a:solidFill>
                            <a:srgbClr val="000000"/>
                          </a:solidFill>
                          <a:latin typeface="Arial Narrow"/>
                        </a:rPr>
                        <a:t>1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-14-2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M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Parent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13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lt;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 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.D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rowSpan="6"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44</a:t>
                      </a: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.D.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6"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&gt;1.5 x 10</a:t>
                      </a:r>
                      <a:r>
                        <a:rPr b="1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 x 10</a:t>
                      </a:r>
                      <a:r>
                        <a:rPr b="0" lang="en-US" sz="1100" spc="-1" strike="noStrike" baseline="12000">
                          <a:solidFill>
                            <a:srgbClr val="000000"/>
                          </a:solidFill>
                          <a:latin typeface="Arial Narrow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0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.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59" name="직선 연결선 7"/>
          <p:cNvSpPr/>
          <p:nvPr/>
        </p:nvSpPr>
        <p:spPr>
          <a:xfrm>
            <a:off x="1415880" y="936720"/>
            <a:ext cx="149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직선 연결선 67"/>
          <p:cNvSpPr/>
          <p:nvPr/>
        </p:nvSpPr>
        <p:spPr>
          <a:xfrm>
            <a:off x="4452840" y="936720"/>
            <a:ext cx="151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1" name="직선 연결선 68"/>
          <p:cNvSpPr/>
          <p:nvPr/>
        </p:nvSpPr>
        <p:spPr>
          <a:xfrm>
            <a:off x="7516800" y="936720"/>
            <a:ext cx="151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2" name="직선 연결선 4"/>
          <p:cNvSpPr/>
          <p:nvPr/>
        </p:nvSpPr>
        <p:spPr>
          <a:xfrm>
            <a:off x="98280" y="768240"/>
            <a:ext cx="8947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3" name="직선 연결선 19"/>
          <p:cNvSpPr/>
          <p:nvPr/>
        </p:nvSpPr>
        <p:spPr>
          <a:xfrm>
            <a:off x="98280" y="6143760"/>
            <a:ext cx="89474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4" name="직선 연결선 20"/>
          <p:cNvSpPr/>
          <p:nvPr/>
        </p:nvSpPr>
        <p:spPr>
          <a:xfrm>
            <a:off x="98280" y="2112840"/>
            <a:ext cx="894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5" name="직선 연결선 21"/>
          <p:cNvSpPr/>
          <p:nvPr/>
        </p:nvSpPr>
        <p:spPr>
          <a:xfrm>
            <a:off x="98280" y="3121200"/>
            <a:ext cx="894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직선 연결선 22"/>
          <p:cNvSpPr/>
          <p:nvPr/>
        </p:nvSpPr>
        <p:spPr>
          <a:xfrm>
            <a:off x="98280" y="4124160"/>
            <a:ext cx="894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직선 연결선 23"/>
          <p:cNvSpPr/>
          <p:nvPr/>
        </p:nvSpPr>
        <p:spPr>
          <a:xfrm>
            <a:off x="98280" y="5130720"/>
            <a:ext cx="894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직선 연결선 18"/>
          <p:cNvSpPr/>
          <p:nvPr/>
        </p:nvSpPr>
        <p:spPr>
          <a:xfrm>
            <a:off x="98280" y="1104840"/>
            <a:ext cx="8947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69" name="Group 9"/>
          <p:cNvGrpSpPr/>
          <p:nvPr/>
        </p:nvGrpSpPr>
        <p:grpSpPr>
          <a:xfrm>
            <a:off x="3021120" y="795240"/>
            <a:ext cx="21960" cy="5322960"/>
            <a:chOff x="3021120" y="795240"/>
            <a:chExt cx="21960" cy="5322960"/>
          </a:xfrm>
        </p:grpSpPr>
        <p:grpSp>
          <p:nvGrpSpPr>
            <p:cNvPr id="70" name="Group 4"/>
            <p:cNvGrpSpPr/>
            <p:nvPr/>
          </p:nvGrpSpPr>
          <p:grpSpPr>
            <a:xfrm>
              <a:off x="3021120" y="795240"/>
              <a:ext cx="21960" cy="288000"/>
              <a:chOff x="3021120" y="795240"/>
              <a:chExt cx="21960" cy="288000"/>
            </a:xfrm>
          </p:grpSpPr>
          <p:sp>
            <p:nvSpPr>
              <p:cNvPr id="71" name="직선 연결선 29"/>
              <p:cNvSpPr/>
              <p:nvPr/>
            </p:nvSpPr>
            <p:spPr>
              <a:xfrm>
                <a:off x="3021120" y="795240"/>
                <a:ext cx="0" cy="28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2" name="직선 연결선 30"/>
              <p:cNvSpPr/>
              <p:nvPr/>
            </p:nvSpPr>
            <p:spPr>
              <a:xfrm>
                <a:off x="3043080" y="795240"/>
                <a:ext cx="0" cy="28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73" name="Group 31"/>
            <p:cNvGrpSpPr/>
            <p:nvPr/>
          </p:nvGrpSpPr>
          <p:grpSpPr>
            <a:xfrm>
              <a:off x="3021120" y="1122840"/>
              <a:ext cx="21960" cy="972000"/>
              <a:chOff x="3021120" y="1122840"/>
              <a:chExt cx="21960" cy="972000"/>
            </a:xfrm>
          </p:grpSpPr>
          <p:sp>
            <p:nvSpPr>
              <p:cNvPr id="74" name="직선 연결선 29"/>
              <p:cNvSpPr/>
              <p:nvPr/>
            </p:nvSpPr>
            <p:spPr>
              <a:xfrm>
                <a:off x="3021120" y="112284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5" name="직선 연결선 30"/>
              <p:cNvSpPr/>
              <p:nvPr/>
            </p:nvSpPr>
            <p:spPr>
              <a:xfrm>
                <a:off x="3043080" y="112284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76" name="Group 34"/>
            <p:cNvGrpSpPr/>
            <p:nvPr/>
          </p:nvGrpSpPr>
          <p:grpSpPr>
            <a:xfrm>
              <a:off x="3021120" y="2128680"/>
              <a:ext cx="21960" cy="972000"/>
              <a:chOff x="3021120" y="2128680"/>
              <a:chExt cx="21960" cy="972000"/>
            </a:xfrm>
          </p:grpSpPr>
          <p:sp>
            <p:nvSpPr>
              <p:cNvPr id="77" name="직선 연결선 29"/>
              <p:cNvSpPr/>
              <p:nvPr/>
            </p:nvSpPr>
            <p:spPr>
              <a:xfrm>
                <a:off x="3021120" y="212868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78" name="직선 연결선 30"/>
              <p:cNvSpPr/>
              <p:nvPr/>
            </p:nvSpPr>
            <p:spPr>
              <a:xfrm>
                <a:off x="3043080" y="212868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79" name="Group 37"/>
            <p:cNvGrpSpPr/>
            <p:nvPr/>
          </p:nvGrpSpPr>
          <p:grpSpPr>
            <a:xfrm>
              <a:off x="3021120" y="3134520"/>
              <a:ext cx="21960" cy="972000"/>
              <a:chOff x="3021120" y="3134520"/>
              <a:chExt cx="21960" cy="972000"/>
            </a:xfrm>
          </p:grpSpPr>
          <p:sp>
            <p:nvSpPr>
              <p:cNvPr id="80" name="직선 연결선 29"/>
              <p:cNvSpPr/>
              <p:nvPr/>
            </p:nvSpPr>
            <p:spPr>
              <a:xfrm>
                <a:off x="3021120" y="313452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1" name="직선 연결선 30"/>
              <p:cNvSpPr/>
              <p:nvPr/>
            </p:nvSpPr>
            <p:spPr>
              <a:xfrm>
                <a:off x="3043080" y="313452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82" name="Group 40"/>
            <p:cNvGrpSpPr/>
            <p:nvPr/>
          </p:nvGrpSpPr>
          <p:grpSpPr>
            <a:xfrm>
              <a:off x="3021120" y="4140360"/>
              <a:ext cx="21960" cy="972000"/>
              <a:chOff x="3021120" y="4140360"/>
              <a:chExt cx="21960" cy="972000"/>
            </a:xfrm>
          </p:grpSpPr>
          <p:sp>
            <p:nvSpPr>
              <p:cNvPr id="83" name="직선 연결선 29"/>
              <p:cNvSpPr/>
              <p:nvPr/>
            </p:nvSpPr>
            <p:spPr>
              <a:xfrm>
                <a:off x="3021120" y="414036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4" name="직선 연결선 30"/>
              <p:cNvSpPr/>
              <p:nvPr/>
            </p:nvSpPr>
            <p:spPr>
              <a:xfrm>
                <a:off x="3043080" y="414036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85" name="Group 43"/>
            <p:cNvGrpSpPr/>
            <p:nvPr/>
          </p:nvGrpSpPr>
          <p:grpSpPr>
            <a:xfrm>
              <a:off x="3021120" y="5146200"/>
              <a:ext cx="21960" cy="972000"/>
              <a:chOff x="3021120" y="5146200"/>
              <a:chExt cx="21960" cy="972000"/>
            </a:xfrm>
          </p:grpSpPr>
          <p:sp>
            <p:nvSpPr>
              <p:cNvPr id="86" name="직선 연결선 29"/>
              <p:cNvSpPr/>
              <p:nvPr/>
            </p:nvSpPr>
            <p:spPr>
              <a:xfrm>
                <a:off x="3021120" y="514620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87" name="직선 연결선 30"/>
              <p:cNvSpPr/>
              <p:nvPr/>
            </p:nvSpPr>
            <p:spPr>
              <a:xfrm>
                <a:off x="3043080" y="514620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pSp>
        <p:nvGrpSpPr>
          <p:cNvPr id="88" name="Group 8"/>
          <p:cNvGrpSpPr/>
          <p:nvPr/>
        </p:nvGrpSpPr>
        <p:grpSpPr>
          <a:xfrm>
            <a:off x="6081840" y="795240"/>
            <a:ext cx="21960" cy="5322960"/>
            <a:chOff x="6081840" y="795240"/>
            <a:chExt cx="21960" cy="5322960"/>
          </a:xfrm>
        </p:grpSpPr>
        <p:grpSp>
          <p:nvGrpSpPr>
            <p:cNvPr id="89" name="Group 7"/>
            <p:cNvGrpSpPr/>
            <p:nvPr/>
          </p:nvGrpSpPr>
          <p:grpSpPr>
            <a:xfrm>
              <a:off x="6081840" y="795240"/>
              <a:ext cx="21960" cy="288000"/>
              <a:chOff x="6081840" y="795240"/>
              <a:chExt cx="21960" cy="288000"/>
            </a:xfrm>
          </p:grpSpPr>
          <p:sp>
            <p:nvSpPr>
              <p:cNvPr id="90" name="직선 연결선 29"/>
              <p:cNvSpPr/>
              <p:nvPr/>
            </p:nvSpPr>
            <p:spPr>
              <a:xfrm>
                <a:off x="6081840" y="795240"/>
                <a:ext cx="0" cy="28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1" name="직선 연결선 30"/>
              <p:cNvSpPr/>
              <p:nvPr/>
            </p:nvSpPr>
            <p:spPr>
              <a:xfrm>
                <a:off x="6103800" y="795240"/>
                <a:ext cx="0" cy="28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92" name="Group 47"/>
            <p:cNvGrpSpPr/>
            <p:nvPr/>
          </p:nvGrpSpPr>
          <p:grpSpPr>
            <a:xfrm>
              <a:off x="6081840" y="1122840"/>
              <a:ext cx="21960" cy="972000"/>
              <a:chOff x="6081840" y="1122840"/>
              <a:chExt cx="21960" cy="972000"/>
            </a:xfrm>
          </p:grpSpPr>
          <p:sp>
            <p:nvSpPr>
              <p:cNvPr id="93" name="직선 연결선 29"/>
              <p:cNvSpPr/>
              <p:nvPr/>
            </p:nvSpPr>
            <p:spPr>
              <a:xfrm>
                <a:off x="6081840" y="112284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4" name="직선 연결선 30"/>
              <p:cNvSpPr/>
              <p:nvPr/>
            </p:nvSpPr>
            <p:spPr>
              <a:xfrm>
                <a:off x="6103800" y="112284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95" name="Group 48"/>
            <p:cNvGrpSpPr/>
            <p:nvPr/>
          </p:nvGrpSpPr>
          <p:grpSpPr>
            <a:xfrm>
              <a:off x="6081840" y="2128680"/>
              <a:ext cx="21960" cy="972000"/>
              <a:chOff x="6081840" y="2128680"/>
              <a:chExt cx="21960" cy="972000"/>
            </a:xfrm>
          </p:grpSpPr>
          <p:sp>
            <p:nvSpPr>
              <p:cNvPr id="96" name="직선 연결선 29"/>
              <p:cNvSpPr/>
              <p:nvPr/>
            </p:nvSpPr>
            <p:spPr>
              <a:xfrm>
                <a:off x="6081840" y="212868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97" name="직선 연결선 30"/>
              <p:cNvSpPr/>
              <p:nvPr/>
            </p:nvSpPr>
            <p:spPr>
              <a:xfrm>
                <a:off x="6103800" y="212868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98" name="Group 49"/>
            <p:cNvGrpSpPr/>
            <p:nvPr/>
          </p:nvGrpSpPr>
          <p:grpSpPr>
            <a:xfrm>
              <a:off x="6081840" y="3134520"/>
              <a:ext cx="21960" cy="972000"/>
              <a:chOff x="6081840" y="3134520"/>
              <a:chExt cx="21960" cy="972000"/>
            </a:xfrm>
          </p:grpSpPr>
          <p:sp>
            <p:nvSpPr>
              <p:cNvPr id="99" name="직선 연결선 29"/>
              <p:cNvSpPr/>
              <p:nvPr/>
            </p:nvSpPr>
            <p:spPr>
              <a:xfrm>
                <a:off x="6081840" y="313452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0" name="직선 연결선 30"/>
              <p:cNvSpPr/>
              <p:nvPr/>
            </p:nvSpPr>
            <p:spPr>
              <a:xfrm>
                <a:off x="6103800" y="313452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101" name="Group 50"/>
            <p:cNvGrpSpPr/>
            <p:nvPr/>
          </p:nvGrpSpPr>
          <p:grpSpPr>
            <a:xfrm>
              <a:off x="6081840" y="4140360"/>
              <a:ext cx="21960" cy="972000"/>
              <a:chOff x="6081840" y="4140360"/>
              <a:chExt cx="21960" cy="972000"/>
            </a:xfrm>
          </p:grpSpPr>
          <p:sp>
            <p:nvSpPr>
              <p:cNvPr id="102" name="직선 연결선 29"/>
              <p:cNvSpPr/>
              <p:nvPr/>
            </p:nvSpPr>
            <p:spPr>
              <a:xfrm>
                <a:off x="6081840" y="414036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3" name="직선 연결선 30"/>
              <p:cNvSpPr/>
              <p:nvPr/>
            </p:nvSpPr>
            <p:spPr>
              <a:xfrm>
                <a:off x="6103800" y="414036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104" name="Group 51"/>
            <p:cNvGrpSpPr/>
            <p:nvPr/>
          </p:nvGrpSpPr>
          <p:grpSpPr>
            <a:xfrm>
              <a:off x="6081840" y="5146200"/>
              <a:ext cx="21960" cy="972000"/>
              <a:chOff x="6081840" y="5146200"/>
              <a:chExt cx="21960" cy="972000"/>
            </a:xfrm>
          </p:grpSpPr>
          <p:sp>
            <p:nvSpPr>
              <p:cNvPr id="105" name="직선 연결선 29"/>
              <p:cNvSpPr/>
              <p:nvPr/>
            </p:nvSpPr>
            <p:spPr>
              <a:xfrm>
                <a:off x="6081840" y="514620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06" name="직선 연결선 30"/>
              <p:cNvSpPr/>
              <p:nvPr/>
            </p:nvSpPr>
            <p:spPr>
              <a:xfrm>
                <a:off x="6103800" y="5146200"/>
                <a:ext cx="0" cy="97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sp>
        <p:nvSpPr>
          <p:cNvPr id="107" name="Text Box 778"/>
          <p:cNvSpPr/>
          <p:nvPr/>
        </p:nvSpPr>
        <p:spPr>
          <a:xfrm>
            <a:off x="7277760" y="0"/>
            <a:ext cx="186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Table S3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Rectangle 4"/>
          <p:cNvSpPr/>
          <p:nvPr/>
        </p:nvSpPr>
        <p:spPr>
          <a:xfrm>
            <a:off x="11160" y="490680"/>
            <a:ext cx="604044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eurovirulence of SA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1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4-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MCV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its 14 E-244 mutants in 3-week-old ICR mice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TextBox 6"/>
          <p:cNvSpPr/>
          <p:nvPr/>
        </p:nvSpPr>
        <p:spPr>
          <a:xfrm>
            <a:off x="39240" y="6119640"/>
            <a:ext cx="129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 Narrow"/>
              </a:rPr>
              <a:t>N.D., Not determined.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dcterms:modified xsi:type="dcterms:W3CDTF">2014-01-30T00:30:14Z</dcterms:modified>
  <cp:revision>153</cp:revision>
  <dc:subject/>
  <dc:title>PowerPoint 프레젠테이션</dc:title>
</cp:coreProperties>
</file>